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5" r:id="rId3"/>
    <p:sldId id="258" r:id="rId4"/>
    <p:sldId id="260" r:id="rId5"/>
    <p:sldId id="262" r:id="rId6"/>
    <p:sldId id="264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81" d="100"/>
          <a:sy n="81" d="100"/>
        </p:scale>
        <p:origin x="31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291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98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465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8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267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898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891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356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643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017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973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0AA12-765D-4192-8A5A-D24CD26A6ECF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36A44-4EA2-4205-A80C-4882E90A706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938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99937" y="277396"/>
            <a:ext cx="62966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pt-PT" sz="1200" b="1" dirty="0"/>
              <a:t>Supplementary material 1: </a:t>
            </a:r>
            <a:r>
              <a:rPr lang="pt-PT" sz="1200" dirty="0"/>
              <a:t>SRA Validation of  identified mutations in cetacea.</a:t>
            </a:r>
            <a:endParaRPr kumimoji="0" lang="pt-PT" sz="12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</a:endParaRPr>
          </a:p>
        </p:txBody>
      </p:sp>
      <p:grpSp>
        <p:nvGrpSpPr>
          <p:cNvPr id="2" name="Grupo 1"/>
          <p:cNvGrpSpPr/>
          <p:nvPr/>
        </p:nvGrpSpPr>
        <p:grpSpPr>
          <a:xfrm>
            <a:off x="190500" y="573902"/>
            <a:ext cx="6460659" cy="4051277"/>
            <a:chOff x="190500" y="573902"/>
            <a:chExt cx="6460659" cy="405127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50213" t="12733" r="11357" b="12784"/>
            <a:stretch/>
          </p:blipFill>
          <p:spPr>
            <a:xfrm>
              <a:off x="272502" y="1184909"/>
              <a:ext cx="6300452" cy="3440270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190500" y="573902"/>
              <a:ext cx="646065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i="1" dirty="0" err="1"/>
                <a:t>Orcinus</a:t>
              </a:r>
              <a:r>
                <a:rPr lang="en-US" sz="1100" b="1" i="1" dirty="0"/>
                <a:t> orca</a:t>
              </a:r>
              <a:r>
                <a:rPr lang="pt-PT" sz="1100" b="1" dirty="0"/>
                <a:t> SRA confirmation of stop codon in exon 2.</a:t>
              </a:r>
            </a:p>
            <a:p>
              <a:pPr algn="just"/>
              <a:r>
                <a:rPr lang="pt-PT" sz="1000" dirty="0"/>
                <a:t>SRA searched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1164379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University of Durham </a:t>
              </a:r>
              <a:r>
                <a:rPr lang="pt-PT" sz="1000" dirty="0">
                  <a:cs typeface="Arial" panose="020B0604020202020204" pitchFamily="34" charset="0"/>
                </a:rPr>
                <a:t>2014-02-13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2595096 (AR-Genome)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374844" y="1189686"/>
              <a:ext cx="197922" cy="343549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99937" y="4651411"/>
            <a:ext cx="6673593" cy="5130824"/>
            <a:chOff x="184407" y="1052381"/>
            <a:chExt cx="6673593" cy="5130824"/>
          </a:xfrm>
        </p:grpSpPr>
        <p:sp>
          <p:nvSpPr>
            <p:cNvPr id="13" name="TextBox 9"/>
            <p:cNvSpPr txBox="1"/>
            <p:nvPr/>
          </p:nvSpPr>
          <p:spPr>
            <a:xfrm>
              <a:off x="184407" y="1052381"/>
              <a:ext cx="6673593" cy="561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050" b="1" i="1" dirty="0" err="1">
                  <a:cs typeface="Arial" panose="020B0604020202020204" pitchFamily="34" charset="0"/>
                </a:rPr>
                <a:t>Lagenorhynchus</a:t>
              </a:r>
              <a:r>
                <a:rPr lang="pt-PT" sz="1050" b="1" i="1" dirty="0">
                  <a:cs typeface="Arial" panose="020B0604020202020204" pitchFamily="34" charset="0"/>
                </a:rPr>
                <a:t> </a:t>
              </a:r>
              <a:r>
                <a:rPr lang="pt-PT" sz="1050" b="1" i="1" dirty="0" err="1">
                  <a:cs typeface="Arial" panose="020B0604020202020204" pitchFamily="34" charset="0"/>
                </a:rPr>
                <a:t>obliquidens</a:t>
              </a:r>
              <a:r>
                <a:rPr lang="pt-PT" sz="1050" b="1" i="1" dirty="0">
                  <a:cs typeface="Arial" panose="020B0604020202020204" pitchFamily="34" charset="0"/>
                </a:rPr>
                <a:t> </a:t>
              </a:r>
              <a:r>
                <a:rPr lang="pt-PT" sz="1050" b="1" dirty="0" err="1"/>
                <a:t>confirmation</a:t>
              </a:r>
              <a:r>
                <a:rPr lang="pt-PT" sz="1050" b="1" dirty="0"/>
                <a:t> </a:t>
              </a:r>
              <a:r>
                <a:rPr lang="pt-PT" sz="1050" b="1" dirty="0" err="1"/>
                <a:t>of</a:t>
              </a:r>
              <a:r>
                <a:rPr lang="pt-PT" sz="1050" b="1" dirty="0"/>
                <a:t> stop </a:t>
              </a:r>
              <a:r>
                <a:rPr lang="pt-PT" sz="1050" b="1" dirty="0" err="1"/>
                <a:t>codon</a:t>
              </a:r>
              <a:r>
                <a:rPr lang="pt-PT" sz="1050" b="1" dirty="0"/>
                <a:t> in </a:t>
              </a:r>
              <a:r>
                <a:rPr lang="pt-PT" sz="1050" b="1" dirty="0" err="1"/>
                <a:t>exon</a:t>
              </a:r>
              <a:r>
                <a:rPr lang="pt-PT" sz="1050" b="1" dirty="0"/>
                <a:t> 2.</a:t>
              </a:r>
              <a:endParaRPr lang="pt-PT" sz="1050" b="1" i="1" dirty="0">
                <a:cs typeface="Arial" panose="020B0604020202020204" pitchFamily="34" charset="0"/>
              </a:endParaRPr>
            </a:p>
            <a:p>
              <a:r>
                <a:rPr lang="pt-PT" sz="1000" dirty="0">
                  <a:cs typeface="Arial" panose="020B0604020202020204" pitchFamily="34" charset="0"/>
                </a:rPr>
                <a:t>SRA </a:t>
              </a:r>
              <a:r>
                <a:rPr lang="pt-PT" sz="1000" dirty="0" err="1">
                  <a:cs typeface="Arial" panose="020B0604020202020204" pitchFamily="34" charset="0"/>
                </a:rPr>
                <a:t>searched</a:t>
              </a:r>
              <a:r>
                <a:rPr lang="pt-PT" sz="1000" dirty="0">
                  <a:cs typeface="Arial" panose="020B0604020202020204" pitchFamily="34" charset="0"/>
                </a:rPr>
                <a:t> </a:t>
              </a:r>
            </a:p>
            <a:p>
              <a:r>
                <a:rPr lang="pt-PT" sz="1000" b="1" dirty="0"/>
                <a:t>SRR7345555</a:t>
              </a:r>
              <a:r>
                <a:rPr lang="pt-PT" sz="1000" dirty="0"/>
                <a:t>- </a:t>
              </a:r>
              <a:r>
                <a:rPr lang="pt-PT" sz="1000" dirty="0">
                  <a:cs typeface="Arial" panose="020B0604020202020204" pitchFamily="34" charset="0"/>
                </a:rPr>
                <a:t>BC </a:t>
              </a:r>
              <a:r>
                <a:rPr lang="pt-PT" sz="1000" dirty="0" err="1">
                  <a:cs typeface="Arial" panose="020B0604020202020204" pitchFamily="34" charset="0"/>
                </a:rPr>
                <a:t>Cancer</a:t>
              </a:r>
              <a:r>
                <a:rPr lang="pt-PT" sz="1000" dirty="0">
                  <a:cs typeface="Arial" panose="020B0604020202020204" pitchFamily="34" charset="0"/>
                </a:rPr>
                <a:t> </a:t>
              </a:r>
              <a:r>
                <a:rPr lang="pt-PT" sz="1000" dirty="0" err="1">
                  <a:cs typeface="Arial" panose="020B0604020202020204" pitchFamily="34" charset="0"/>
                </a:rPr>
                <a:t>Agency</a:t>
              </a:r>
              <a:r>
                <a:rPr lang="pt-PT" sz="1000" dirty="0">
                  <a:cs typeface="Arial" panose="020B0604020202020204" pitchFamily="34" charset="0"/>
                </a:rPr>
                <a:t> Michael Smith </a:t>
              </a:r>
              <a:r>
                <a:rPr lang="pt-PT" sz="1000" dirty="0" err="1">
                  <a:cs typeface="Arial" panose="020B0604020202020204" pitchFamily="34" charset="0"/>
                </a:rPr>
                <a:t>Genome</a:t>
              </a:r>
              <a:r>
                <a:rPr lang="pt-PT" sz="1000" dirty="0">
                  <a:cs typeface="Arial" panose="020B0604020202020204" pitchFamily="34" charset="0"/>
                </a:rPr>
                <a:t> </a:t>
              </a:r>
              <a:r>
                <a:rPr lang="pt-PT" sz="1000" dirty="0" err="1">
                  <a:cs typeface="Arial" panose="020B0604020202020204" pitchFamily="34" charset="0"/>
                </a:rPr>
                <a:t>Sciences</a:t>
              </a:r>
              <a:r>
                <a:rPr lang="pt-PT" sz="1000" dirty="0">
                  <a:cs typeface="Arial" panose="020B0604020202020204" pitchFamily="34" charset="0"/>
                </a:rPr>
                <a:t> </a:t>
              </a:r>
              <a:r>
                <a:rPr lang="pt-PT" sz="1000" dirty="0" err="1">
                  <a:cs typeface="Arial" panose="020B0604020202020204" pitchFamily="34" charset="0"/>
                </a:rPr>
                <a:t>Center</a:t>
              </a:r>
              <a:r>
                <a:rPr lang="pt-PT" sz="1000" dirty="0">
                  <a:cs typeface="Arial" panose="020B0604020202020204" pitchFamily="34" charset="0"/>
                </a:rPr>
                <a:t> (BCCAGSC) 2018-06-21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9386610</a:t>
              </a:r>
              <a:endParaRPr lang="pt-PT" sz="1000" b="1" dirty="0"/>
            </a:p>
          </p:txBody>
        </p:sp>
        <p:pic>
          <p:nvPicPr>
            <p:cNvPr id="14" name="Imagem 13"/>
            <p:cNvPicPr>
              <a:picLocks noChangeAspect="1"/>
            </p:cNvPicPr>
            <p:nvPr/>
          </p:nvPicPr>
          <p:blipFill rotWithShape="1">
            <a:blip r:embed="rId3"/>
            <a:srcRect l="44997" t="8877" r="15628" b="8590"/>
            <a:stretch/>
          </p:blipFill>
          <p:spPr>
            <a:xfrm>
              <a:off x="266408" y="1565457"/>
              <a:ext cx="6391015" cy="46177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Rectangle 9"/>
            <p:cNvSpPr/>
            <p:nvPr/>
          </p:nvSpPr>
          <p:spPr>
            <a:xfrm>
              <a:off x="4554824" y="1564717"/>
              <a:ext cx="183839" cy="461848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28976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o 9"/>
          <p:cNvGrpSpPr/>
          <p:nvPr/>
        </p:nvGrpSpPr>
        <p:grpSpPr>
          <a:xfrm>
            <a:off x="131841" y="1195670"/>
            <a:ext cx="6411749" cy="4187989"/>
            <a:chOff x="111293" y="5058753"/>
            <a:chExt cx="6411749" cy="4187989"/>
          </a:xfrm>
        </p:grpSpPr>
        <p:grpSp>
          <p:nvGrpSpPr>
            <p:cNvPr id="6" name="Group 10"/>
            <p:cNvGrpSpPr/>
            <p:nvPr/>
          </p:nvGrpSpPr>
          <p:grpSpPr>
            <a:xfrm>
              <a:off x="111293" y="5058753"/>
              <a:ext cx="6411749" cy="4187989"/>
              <a:chOff x="101019" y="5048479"/>
              <a:chExt cx="6411749" cy="4187989"/>
            </a:xfrm>
          </p:grpSpPr>
          <p:pic>
            <p:nvPicPr>
              <p:cNvPr id="7" name="Picture 7"/>
              <p:cNvPicPr>
                <a:picLocks noChangeAspect="1"/>
              </p:cNvPicPr>
              <p:nvPr/>
            </p:nvPicPr>
            <p:blipFill rotWithShape="1">
              <a:blip r:embed="rId2"/>
              <a:srcRect l="50219" t="12447" r="11162" b="12285"/>
              <a:stretch/>
            </p:blipFill>
            <p:spPr>
              <a:xfrm>
                <a:off x="164889" y="5750821"/>
                <a:ext cx="6347879" cy="3485647"/>
              </a:xfrm>
              <a:prstGeom prst="rect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8" name="TextBox 8"/>
              <p:cNvSpPr txBox="1"/>
              <p:nvPr/>
            </p:nvSpPr>
            <p:spPr>
              <a:xfrm>
                <a:off x="101019" y="5048479"/>
                <a:ext cx="6295577" cy="7232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100" b="1" i="1" dirty="0" err="1"/>
                  <a:t>Tursiops</a:t>
                </a:r>
                <a:r>
                  <a:rPr lang="en-US" sz="1100" b="1" i="1" dirty="0"/>
                  <a:t> </a:t>
                </a:r>
                <a:r>
                  <a:rPr lang="en-US" sz="1100" b="1" i="1" dirty="0" err="1"/>
                  <a:t>truncatus</a:t>
                </a:r>
                <a:r>
                  <a:rPr lang="pt-PT" sz="1100" b="1" dirty="0"/>
                  <a:t> SRA confirmation of stop codon in exon 3.</a:t>
                </a:r>
              </a:p>
              <a:p>
                <a:pPr algn="just"/>
                <a:r>
                  <a:rPr lang="pt-PT" sz="1000" dirty="0">
                    <a:cs typeface="Arial" panose="020B0604020202020204" pitchFamily="34" charset="0"/>
                  </a:rPr>
                  <a:t>SRA searched </a:t>
                </a:r>
                <a:endParaRPr lang="pt-PT" sz="1000" dirty="0"/>
              </a:p>
              <a:p>
                <a:pPr algn="just"/>
                <a:r>
                  <a:rPr lang="pt-PT" sz="1000" b="1" dirty="0"/>
                  <a:t>SRR5125024 </a:t>
                </a:r>
                <a:r>
                  <a:rPr lang="en-US" sz="1000" dirty="0">
                    <a:cs typeface="Arial" panose="020B0604020202020204" pitchFamily="34" charset="0"/>
                  </a:rPr>
                  <a:t>National Institute of Standards and Technology </a:t>
                </a:r>
                <a:r>
                  <a:rPr lang="pt-PT" sz="1000" dirty="0">
                    <a:cs typeface="Arial" panose="020B0604020202020204" pitchFamily="34" charset="0"/>
                  </a:rPr>
                  <a:t>2016-12-27 </a:t>
                </a:r>
                <a:r>
                  <a:rPr lang="pt-PT" sz="10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000" dirty="0">
                    <a:cs typeface="Arial" panose="020B0604020202020204" pitchFamily="34" charset="0"/>
                  </a:rPr>
                  <a:t>SAMN06114300 (ACU285439A)</a:t>
                </a:r>
                <a:endParaRPr lang="pt-PT" sz="1000" dirty="0"/>
              </a:p>
              <a:p>
                <a:pPr algn="just"/>
                <a:r>
                  <a:rPr lang="pt-PT" sz="1000" b="1" dirty="0"/>
                  <a:t>SRR606319/SRR606321 </a:t>
                </a:r>
                <a:r>
                  <a:rPr lang="pt-PT" sz="1000" dirty="0">
                    <a:cs typeface="Arial" panose="020B0604020202020204" pitchFamily="34" charset="0"/>
                  </a:rPr>
                  <a:t>Baylor College of Medicine 2015-07-22 </a:t>
                </a:r>
                <a:r>
                  <a:rPr lang="pt-PT" sz="10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000" dirty="0">
                    <a:cs typeface="Arial" panose="020B0604020202020204" pitchFamily="34" charset="0"/>
                  </a:rPr>
                  <a:t>SAMN00000070</a:t>
                </a:r>
                <a:endParaRPr lang="pt-PT" sz="1000" dirty="0"/>
              </a:p>
            </p:txBody>
          </p:sp>
        </p:grpSp>
        <p:sp>
          <p:nvSpPr>
            <p:cNvPr id="9" name="Rectangle 9"/>
            <p:cNvSpPr/>
            <p:nvPr/>
          </p:nvSpPr>
          <p:spPr>
            <a:xfrm>
              <a:off x="4327190" y="5746545"/>
              <a:ext cx="217714" cy="343549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457190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7574" y="191354"/>
            <a:ext cx="6700426" cy="4254829"/>
            <a:chOff x="157574" y="191354"/>
            <a:chExt cx="6700426" cy="425482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50279" t="12659" r="11341" b="11917"/>
            <a:stretch/>
          </p:blipFill>
          <p:spPr>
            <a:xfrm>
              <a:off x="277339" y="915037"/>
              <a:ext cx="6377872" cy="3531146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157574" y="191354"/>
              <a:ext cx="6700426" cy="87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100" b="1" i="1" dirty="0">
                  <a:cs typeface="Arial" panose="020B0604020202020204" pitchFamily="34" charset="0"/>
                </a:rPr>
                <a:t>Delphinapterus leucas </a:t>
              </a:r>
              <a:r>
                <a:rPr lang="pt-PT" sz="1100" b="1" dirty="0"/>
                <a:t>SRA confirmation of stop codon in exon 3.</a:t>
              </a:r>
            </a:p>
            <a:p>
              <a:r>
                <a:rPr lang="pt-PT" sz="1000" dirty="0"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5197962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BC Cancer Agency Michael Smith Genome Sciences Centre </a:t>
              </a:r>
              <a:r>
                <a:rPr lang="pt-PT" sz="1000" dirty="0">
                  <a:cs typeface="Arial" panose="020B0604020202020204" pitchFamily="34" charset="0"/>
                </a:rPr>
                <a:t> 2017-06-27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6217832  (Qila21)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5197961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BC Cancer Agency Michael Smith Genome Sciences Centre </a:t>
              </a:r>
              <a:r>
                <a:rPr lang="pt-PT" sz="1000" dirty="0">
                  <a:cs typeface="Arial" panose="020B0604020202020204" pitchFamily="34" charset="0"/>
                </a:rPr>
                <a:t> 2017-06-27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6216270 (Aurora29)</a:t>
              </a:r>
            </a:p>
            <a:p>
              <a:endParaRPr lang="pt-PT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Rectangle 4"/>
          <p:cNvSpPr/>
          <p:nvPr/>
        </p:nvSpPr>
        <p:spPr>
          <a:xfrm>
            <a:off x="4226474" y="818784"/>
            <a:ext cx="197922" cy="35311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/>
          <p:cNvGrpSpPr/>
          <p:nvPr/>
        </p:nvGrpSpPr>
        <p:grpSpPr>
          <a:xfrm>
            <a:off x="199446" y="4996994"/>
            <a:ext cx="6455765" cy="4230164"/>
            <a:chOff x="157574" y="4470631"/>
            <a:chExt cx="6455765" cy="4230164"/>
          </a:xfrm>
        </p:grpSpPr>
        <p:grpSp>
          <p:nvGrpSpPr>
            <p:cNvPr id="8" name="Group 7"/>
            <p:cNvGrpSpPr/>
            <p:nvPr/>
          </p:nvGrpSpPr>
          <p:grpSpPr>
            <a:xfrm>
              <a:off x="157574" y="4470631"/>
              <a:ext cx="6455765" cy="4230164"/>
              <a:chOff x="157574" y="4470631"/>
              <a:chExt cx="6455765" cy="4230164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/>
              <a:srcRect l="50159" t="12447" r="11341" b="11918"/>
              <a:stretch/>
            </p:blipFill>
            <p:spPr>
              <a:xfrm>
                <a:off x="277339" y="5193907"/>
                <a:ext cx="6336000" cy="3506888"/>
              </a:xfrm>
              <a:prstGeom prst="rect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57574" y="4470631"/>
                <a:ext cx="6336000" cy="7232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PT" sz="1100" b="1" i="1" dirty="0">
                    <a:cs typeface="Arial" panose="020B0604020202020204" pitchFamily="34" charset="0"/>
                  </a:rPr>
                  <a:t>Neophocaena asiaeorientalis </a:t>
                </a:r>
                <a:r>
                  <a:rPr lang="pt-PT" sz="1100" b="1" dirty="0"/>
                  <a:t>SRA confirmation of stop codon in exon 3.</a:t>
                </a:r>
              </a:p>
              <a:p>
                <a:r>
                  <a:rPr lang="pt-PT" sz="1000" dirty="0">
                    <a:cs typeface="Arial" panose="020B0604020202020204" pitchFamily="34" charset="0"/>
                  </a:rPr>
                  <a:t>SRA searched </a:t>
                </a:r>
              </a:p>
              <a:p>
                <a:r>
                  <a:rPr lang="pt-PT" sz="1000" b="1" dirty="0">
                    <a:cs typeface="Arial" panose="020B0604020202020204" pitchFamily="34" charset="0"/>
                  </a:rPr>
                  <a:t>SRR6923830</a:t>
                </a:r>
                <a:r>
                  <a:rPr lang="pt-PT" sz="1000" dirty="0">
                    <a:cs typeface="Arial" panose="020B0604020202020204" pitchFamily="34" charset="0"/>
                  </a:rPr>
                  <a:t>- </a:t>
                </a:r>
                <a:r>
                  <a:rPr lang="en-US" sz="1000" dirty="0">
                    <a:cs typeface="Arial" panose="020B0604020202020204" pitchFamily="34" charset="0"/>
                  </a:rPr>
                  <a:t>Northwestern </a:t>
                </a:r>
                <a:r>
                  <a:rPr lang="en-US" sz="1000" dirty="0" err="1">
                    <a:cs typeface="Arial" panose="020B0604020202020204" pitchFamily="34" charset="0"/>
                  </a:rPr>
                  <a:t>Polytechnical</a:t>
                </a:r>
                <a:r>
                  <a:rPr lang="en-US" sz="1000" dirty="0">
                    <a:cs typeface="Arial" panose="020B0604020202020204" pitchFamily="34" charset="0"/>
                  </a:rPr>
                  <a:t> University </a:t>
                </a:r>
                <a:r>
                  <a:rPr lang="pt-PT" sz="1000" dirty="0">
                    <a:cs typeface="Arial" panose="020B0604020202020204" pitchFamily="34" charset="0"/>
                  </a:rPr>
                  <a:t>2018-04-08 </a:t>
                </a:r>
                <a:r>
                  <a:rPr lang="pt-PT" sz="10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000" dirty="0">
                    <a:cs typeface="Arial" panose="020B0604020202020204" pitchFamily="34" charset="0"/>
                  </a:rPr>
                  <a:t>SAMN08512128 </a:t>
                </a:r>
              </a:p>
              <a:p>
                <a:r>
                  <a:rPr lang="pt-PT" sz="1000" b="1" dirty="0">
                    <a:cs typeface="Arial" panose="020B0604020202020204" pitchFamily="34" charset="0"/>
                  </a:rPr>
                  <a:t>SRR4292276</a:t>
                </a:r>
                <a:r>
                  <a:rPr lang="pt-PT" sz="1000" dirty="0">
                    <a:cs typeface="Arial" panose="020B0604020202020204" pitchFamily="34" charset="0"/>
                  </a:rPr>
                  <a:t>- </a:t>
                </a:r>
                <a:r>
                  <a:rPr lang="en-US" sz="1000" dirty="0">
                    <a:cs typeface="Arial" panose="020B0604020202020204" pitchFamily="34" charset="0"/>
                  </a:rPr>
                  <a:t>Beijing Genome Institute (BGI) </a:t>
                </a:r>
                <a:r>
                  <a:rPr lang="pt-PT" sz="1000" dirty="0">
                    <a:cs typeface="Arial" panose="020B0604020202020204" pitchFamily="34" charset="0"/>
                  </a:rPr>
                  <a:t> 2017-09-23 </a:t>
                </a:r>
                <a:r>
                  <a:rPr lang="pt-PT" sz="10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000" dirty="0">
                    <a:cs typeface="Arial" panose="020B0604020202020204" pitchFamily="34" charset="0"/>
                  </a:rPr>
                  <a:t>SAMN05818630</a:t>
                </a:r>
                <a:endParaRPr lang="pt-PT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Rectangle 8"/>
            <p:cNvSpPr/>
            <p:nvPr/>
          </p:nvSpPr>
          <p:spPr>
            <a:xfrm>
              <a:off x="4325435" y="5096279"/>
              <a:ext cx="197922" cy="35311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6122257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41916" y="596446"/>
            <a:ext cx="6788277" cy="3430003"/>
            <a:chOff x="141915" y="608477"/>
            <a:chExt cx="6788277" cy="3430003"/>
          </a:xfrm>
        </p:grpSpPr>
        <p:sp>
          <p:nvSpPr>
            <p:cNvPr id="2" name="TextBox 1"/>
            <p:cNvSpPr txBox="1"/>
            <p:nvPr/>
          </p:nvSpPr>
          <p:spPr>
            <a:xfrm>
              <a:off x="141915" y="608477"/>
              <a:ext cx="6788277" cy="8694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050" b="1" i="1" dirty="0">
                  <a:cs typeface="Arial" panose="020B0604020202020204" pitchFamily="34" charset="0"/>
                </a:rPr>
                <a:t>Physeter catodon </a:t>
              </a:r>
              <a:r>
                <a:rPr lang="pt-PT" sz="1050" b="1" dirty="0"/>
                <a:t>SRA confirmation of 1nt deletion in exon 2.</a:t>
              </a:r>
              <a:endParaRPr lang="pt-PT" sz="1000" b="1" i="1" dirty="0">
                <a:cs typeface="Arial" panose="020B0604020202020204" pitchFamily="34" charset="0"/>
              </a:endParaRPr>
            </a:p>
            <a:p>
              <a:r>
                <a:rPr lang="pt-PT" sz="1000" dirty="0"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5146847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The Genome Center at Washington Univ. School of Medicine in St. Louis </a:t>
              </a:r>
              <a:r>
                <a:rPr lang="pt-PT" sz="1000" dirty="0">
                  <a:cs typeface="Arial" panose="020B0604020202020204" pitchFamily="34" charset="0"/>
                </a:rPr>
                <a:t>2017-01-05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6187412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5146843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The Genome Center at Washington </a:t>
              </a:r>
              <a:r>
                <a:rPr lang="en-US" sz="1000" dirty="0" err="1">
                  <a:cs typeface="Arial" panose="020B0604020202020204" pitchFamily="34" charset="0"/>
                </a:rPr>
                <a:t>Univ.School</a:t>
              </a:r>
              <a:r>
                <a:rPr lang="en-US" sz="1000" dirty="0">
                  <a:cs typeface="Arial" panose="020B0604020202020204" pitchFamily="34" charset="0"/>
                </a:rPr>
                <a:t> of Medicine in St. Louis </a:t>
              </a:r>
              <a:r>
                <a:rPr lang="pt-PT" sz="1000" dirty="0">
                  <a:cs typeface="Arial" panose="020B0604020202020204" pitchFamily="34" charset="0"/>
                </a:rPr>
                <a:t>2017-01-05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6187413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5146865-</a:t>
              </a:r>
              <a:r>
                <a:rPr lang="en-US" sz="1000" dirty="0">
                  <a:cs typeface="Arial" panose="020B0604020202020204" pitchFamily="34" charset="0"/>
                </a:rPr>
                <a:t> The Genome Center at Washington Univ. School of Medicine in St. Louis </a:t>
              </a:r>
              <a:r>
                <a:rPr lang="pt-PT" sz="1000" dirty="0">
                  <a:cs typeface="Arial" panose="020B0604020202020204" pitchFamily="34" charset="0"/>
                </a:rPr>
                <a:t>2017-01-05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6187411 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50274" t="23454" r="10625" b="20391"/>
            <a:stretch/>
          </p:blipFill>
          <p:spPr>
            <a:xfrm>
              <a:off x="214108" y="1491610"/>
              <a:ext cx="6294552" cy="2546870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4" name="Rectangle 3"/>
            <p:cNvSpPr/>
            <p:nvPr/>
          </p:nvSpPr>
          <p:spPr>
            <a:xfrm>
              <a:off x="4380286" y="1311646"/>
              <a:ext cx="83939" cy="265300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41916" y="4559504"/>
            <a:ext cx="6476104" cy="4240251"/>
            <a:chOff x="141916" y="4559504"/>
            <a:chExt cx="6476104" cy="424025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50159" t="12659" r="11700" b="11917"/>
            <a:stretch/>
          </p:blipFill>
          <p:spPr>
            <a:xfrm>
              <a:off x="248590" y="5268693"/>
              <a:ext cx="6338059" cy="3531062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7" name="Rectangle 6"/>
            <p:cNvSpPr/>
            <p:nvPr/>
          </p:nvSpPr>
          <p:spPr>
            <a:xfrm>
              <a:off x="141916" y="4559504"/>
              <a:ext cx="6476104" cy="7232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PT" sz="1100" b="1" i="1" dirty="0">
                  <a:cs typeface="Arial" panose="020B0604020202020204" pitchFamily="34" charset="0"/>
                </a:rPr>
                <a:t>Balaenoptera acutorostrata </a:t>
              </a:r>
              <a:r>
                <a:rPr lang="pt-PT" sz="1100" b="1" dirty="0"/>
                <a:t>SRA confirmation of stop codon in exon 2.</a:t>
              </a:r>
              <a:endParaRPr lang="pt-PT" sz="1100" b="1" i="1" dirty="0">
                <a:cs typeface="Arial" panose="020B0604020202020204" pitchFamily="34" charset="0"/>
              </a:endParaRPr>
            </a:p>
            <a:p>
              <a:r>
                <a:rPr lang="pt-PT" sz="1000" dirty="0"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924087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Korea Institute of Ocean Science and Technology </a:t>
              </a:r>
              <a:r>
                <a:rPr lang="pt-PT" sz="1000" dirty="0">
                  <a:cs typeface="Arial" panose="020B0604020202020204" pitchFamily="34" charset="0"/>
                </a:rPr>
                <a:t>2013-10-31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2192644</a:t>
              </a:r>
              <a:r>
                <a:rPr lang="pt-PT" sz="1000" b="1" dirty="0">
                  <a:cs typeface="Arial" panose="020B0604020202020204" pitchFamily="34" charset="0"/>
                </a:rPr>
                <a:t> (</a:t>
              </a:r>
              <a:r>
                <a:rPr lang="pt-PT" sz="1000" dirty="0">
                  <a:cs typeface="Arial" panose="020B0604020202020204" pitchFamily="34" charset="0"/>
                </a:rPr>
                <a:t>MinkeWhale-01)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4011112</a:t>
              </a:r>
              <a:r>
                <a:rPr lang="pt-PT" sz="1000" dirty="0">
                  <a:cs typeface="Arial" panose="020B0604020202020204" pitchFamily="34" charset="0"/>
                </a:rPr>
                <a:t>- Institute of Marine Research 2016-08-13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5447714 (</a:t>
              </a:r>
              <a:r>
                <a:rPr lang="en-US" sz="1000" dirty="0">
                  <a:cs typeface="Arial" panose="020B0604020202020204" pitchFamily="34" charset="0"/>
                </a:rPr>
                <a:t>AT)</a:t>
              </a:r>
              <a:endParaRPr lang="pt-PT" sz="1000" dirty="0">
                <a:cs typeface="Arial" panose="020B0604020202020204" pitchFamily="34" charset="0"/>
              </a:endParaRPr>
            </a:p>
          </p:txBody>
        </p:sp>
      </p:grpSp>
      <p:sp>
        <p:nvSpPr>
          <p:cNvPr id="9" name="Rectangle 8"/>
          <p:cNvSpPr/>
          <p:nvPr/>
        </p:nvSpPr>
        <p:spPr>
          <a:xfrm>
            <a:off x="4407985" y="5255029"/>
            <a:ext cx="197922" cy="35311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6604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224687" y="298723"/>
            <a:ext cx="6558131" cy="4317175"/>
            <a:chOff x="224687" y="298723"/>
            <a:chExt cx="6558131" cy="4317175"/>
          </a:xfrm>
        </p:grpSpPr>
        <p:sp>
          <p:nvSpPr>
            <p:cNvPr id="4" name="TextBox 3"/>
            <p:cNvSpPr txBox="1"/>
            <p:nvPr/>
          </p:nvSpPr>
          <p:spPr>
            <a:xfrm>
              <a:off x="224687" y="298723"/>
              <a:ext cx="655813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100" b="1" i="1" dirty="0">
                  <a:cs typeface="Arial" panose="020B0604020202020204" pitchFamily="34" charset="0"/>
                </a:rPr>
                <a:t>Balaenoptera bonaerensis </a:t>
              </a:r>
              <a:r>
                <a:rPr lang="pt-PT" sz="1100" b="1" dirty="0"/>
                <a:t>confirmation of Stop codon in exon 2.</a:t>
              </a:r>
              <a:endParaRPr lang="pt-PT" sz="1100" b="1" i="1" dirty="0">
                <a:cs typeface="Arial" panose="020B0604020202020204" pitchFamily="34" charset="0"/>
              </a:endParaRPr>
            </a:p>
            <a:p>
              <a:r>
                <a:rPr lang="pt-PT" sz="1100" dirty="0"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100" b="1" dirty="0">
                  <a:cs typeface="Arial" panose="020B0604020202020204" pitchFamily="34" charset="0"/>
                </a:rPr>
                <a:t>SRR4011114</a:t>
              </a:r>
              <a:r>
                <a:rPr lang="pt-PT" sz="1100" dirty="0">
                  <a:cs typeface="Arial" panose="020B0604020202020204" pitchFamily="34" charset="0"/>
                </a:rPr>
                <a:t>- </a:t>
              </a:r>
              <a:r>
                <a:rPr lang="en-US" sz="1100" dirty="0">
                  <a:cs typeface="Arial" panose="020B0604020202020204" pitchFamily="34" charset="0"/>
                </a:rPr>
                <a:t>Institute of Marine Research </a:t>
              </a:r>
              <a:r>
                <a:rPr lang="pt-PT" sz="1100" dirty="0">
                  <a:cs typeface="Arial" panose="020B0604020202020204" pitchFamily="34" charset="0"/>
                </a:rPr>
                <a:t>2016-08-13 </a:t>
              </a:r>
              <a:r>
                <a:rPr lang="pt-PT" sz="1100" b="1" dirty="0">
                  <a:cs typeface="Arial" panose="020B0604020202020204" pitchFamily="34" charset="0"/>
                </a:rPr>
                <a:t>Sample ID: </a:t>
              </a:r>
              <a:r>
                <a:rPr lang="pt-PT" sz="1100" dirty="0">
                  <a:cs typeface="Arial" panose="020B0604020202020204" pitchFamily="34" charset="0"/>
                </a:rPr>
                <a:t>SAMN05447715</a:t>
              </a:r>
            </a:p>
            <a:p>
              <a:r>
                <a:rPr lang="pt-PT" sz="1100" b="1" dirty="0">
                  <a:cs typeface="Arial" panose="020B0604020202020204" pitchFamily="34" charset="0"/>
                </a:rPr>
                <a:t>SRR4011113</a:t>
              </a:r>
              <a:r>
                <a:rPr lang="pt-PT" sz="1100" dirty="0">
                  <a:cs typeface="Arial" panose="020B0604020202020204" pitchFamily="34" charset="0"/>
                </a:rPr>
                <a:t>- Institute of Marine Research 2016-08-13 </a:t>
              </a:r>
              <a:r>
                <a:rPr lang="pt-PT" sz="1100" b="1" dirty="0">
                  <a:cs typeface="Arial" panose="020B0604020202020204" pitchFamily="34" charset="0"/>
                </a:rPr>
                <a:t>Sample ID: </a:t>
              </a:r>
              <a:r>
                <a:rPr lang="pt-PT" sz="1100" dirty="0">
                  <a:cs typeface="Arial" panose="020B0604020202020204" pitchFamily="34" charset="0"/>
                </a:rPr>
                <a:t>SAMN05447715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50338" t="12871" r="11820" b="11917"/>
            <a:stretch/>
          </p:blipFill>
          <p:spPr>
            <a:xfrm>
              <a:off x="299869" y="1068164"/>
              <a:ext cx="6336000" cy="3547734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6" name="Rectangle 5"/>
            <p:cNvSpPr/>
            <p:nvPr/>
          </p:nvSpPr>
          <p:spPr>
            <a:xfrm>
              <a:off x="4442275" y="1084752"/>
              <a:ext cx="197922" cy="35311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224687" y="5041087"/>
            <a:ext cx="6411182" cy="4234803"/>
            <a:chOff x="243326" y="5180453"/>
            <a:chExt cx="6411182" cy="4234803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50277" t="12023" r="11820" b="11918"/>
            <a:stretch/>
          </p:blipFill>
          <p:spPr>
            <a:xfrm>
              <a:off x="281229" y="5803728"/>
              <a:ext cx="6373279" cy="3603162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9" name="Rectângulo arredondado 1973"/>
            <p:cNvSpPr>
              <a:spLocks/>
            </p:cNvSpPr>
            <p:nvPr/>
          </p:nvSpPr>
          <p:spPr>
            <a:xfrm>
              <a:off x="243326" y="5180453"/>
              <a:ext cx="5935561" cy="578813"/>
            </a:xfrm>
            <a:prstGeom prst="roundRect">
              <a:avLst/>
            </a:prstGeom>
            <a:noFill/>
            <a:ln w="317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36000" rIns="0" bIns="36000" rtlCol="0" anchor="ctr">
              <a:noAutofit/>
            </a:bodyPr>
            <a:lstStyle/>
            <a:p>
              <a:r>
                <a:rPr lang="pt-PT" sz="1100" b="1" i="1" dirty="0">
                  <a:solidFill>
                    <a:schemeClr val="tx1"/>
                  </a:solidFill>
                  <a:cs typeface="Arial" panose="020B0604020202020204" pitchFamily="34" charset="0"/>
                </a:rPr>
                <a:t>Eschrichtius robustus </a:t>
              </a:r>
              <a:r>
                <a:rPr lang="pt-PT" sz="1100" b="1" dirty="0">
                  <a:solidFill>
                    <a:schemeClr val="tx1"/>
                  </a:solidFill>
                </a:rPr>
                <a:t>confirmation of Stop codon in exon 2.</a:t>
              </a:r>
              <a:endParaRPr lang="pt-PT" sz="1100" b="1" i="1" dirty="0">
                <a:solidFill>
                  <a:schemeClr val="tx1"/>
                </a:solidFill>
                <a:cs typeface="Arial" panose="020B0604020202020204" pitchFamily="34" charset="0"/>
              </a:endParaRPr>
            </a:p>
            <a:p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000" b="1" dirty="0">
                  <a:solidFill>
                    <a:schemeClr val="tx1"/>
                  </a:solidFill>
                  <a:cs typeface="Arial" panose="020B0604020202020204" pitchFamily="34" charset="0"/>
                </a:rPr>
                <a:t>SRR5495100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- </a:t>
              </a:r>
              <a:r>
                <a:rPr lang="en-US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Purdue University 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2017-05-02 </a:t>
              </a:r>
              <a:r>
                <a:rPr lang="pt-PT" sz="1000" b="1" dirty="0">
                  <a:solidFill>
                    <a:schemeClr val="tx1"/>
                  </a:solidFill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SAMN06837694 (GFD-02)</a:t>
              </a:r>
            </a:p>
            <a:p>
              <a:r>
                <a:rPr lang="pt-PT" sz="1000" b="1" dirty="0">
                  <a:solidFill>
                    <a:schemeClr val="tx1"/>
                  </a:solidFill>
                  <a:cs typeface="Arial" panose="020B0604020202020204" pitchFamily="34" charset="0"/>
                </a:rPr>
                <a:t>SRR5495106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- </a:t>
              </a:r>
              <a:r>
                <a:rPr lang="en-US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Purdue University 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2017-05-02 </a:t>
              </a:r>
              <a:r>
                <a:rPr lang="pt-PT" sz="1000" b="1" dirty="0">
                  <a:solidFill>
                    <a:schemeClr val="tx1"/>
                  </a:solidFill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solidFill>
                    <a:schemeClr val="tx1"/>
                  </a:solidFill>
                  <a:cs typeface="Arial" panose="020B0604020202020204" pitchFamily="34" charset="0"/>
                </a:rPr>
                <a:t>SAMN06837692 (ER-14-168</a:t>
              </a:r>
              <a:r>
                <a:rPr lang="pt-PT" sz="800" dirty="0">
                  <a:solidFill>
                    <a:schemeClr val="tx1"/>
                  </a:solidFill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442275" y="5803728"/>
              <a:ext cx="197922" cy="36115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117670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78836" y="459523"/>
            <a:ext cx="6415767" cy="4207604"/>
            <a:chOff x="251025" y="471554"/>
            <a:chExt cx="6415767" cy="4207604"/>
          </a:xfrm>
        </p:grpSpPr>
        <p:sp>
          <p:nvSpPr>
            <p:cNvPr id="2" name="TextBox 1"/>
            <p:cNvSpPr txBox="1"/>
            <p:nvPr/>
          </p:nvSpPr>
          <p:spPr>
            <a:xfrm>
              <a:off x="251025" y="471554"/>
              <a:ext cx="6336000" cy="723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100" b="1" i="1" dirty="0">
                  <a:cs typeface="Arial" panose="020B0604020202020204" pitchFamily="34" charset="0"/>
                </a:rPr>
                <a:t>Balaena mysticetus </a:t>
              </a:r>
              <a:r>
                <a:rPr lang="pt-PT" sz="1100" b="1" dirty="0">
                  <a:solidFill>
                    <a:schemeClr val="tx1"/>
                  </a:solidFill>
                </a:rPr>
                <a:t>Stop codon in exon 2.</a:t>
              </a:r>
              <a:endParaRPr lang="pt-PT" sz="1100" b="1" i="1" dirty="0">
                <a:cs typeface="Arial" panose="020B0604020202020204" pitchFamily="34" charset="0"/>
              </a:endParaRPr>
            </a:p>
            <a:p>
              <a:r>
                <a:rPr lang="pt-PT" sz="1000" dirty="0">
                  <a:cs typeface="Arial" panose="020B0604020202020204" pitchFamily="34" charset="0"/>
                </a:rPr>
                <a:t>SRA searched 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1685385</a:t>
              </a:r>
              <a:r>
                <a:rPr lang="pt-PT" sz="1000" dirty="0">
                  <a:cs typeface="Arial" panose="020B0604020202020204" pitchFamily="34" charset="0"/>
                </a:rPr>
                <a:t>- </a:t>
              </a:r>
              <a:r>
                <a:rPr lang="en-US" sz="1000" dirty="0">
                  <a:cs typeface="Arial" panose="020B0604020202020204" pitchFamily="34" charset="0"/>
                </a:rPr>
                <a:t>University of Liverpool </a:t>
              </a:r>
              <a:r>
                <a:rPr lang="pt-PT" sz="1000" dirty="0">
                  <a:cs typeface="Arial" panose="020B0604020202020204" pitchFamily="34" charset="0"/>
                </a:rPr>
                <a:t>2015-01-06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3225705 (Bowhead ID325)</a:t>
              </a:r>
            </a:p>
            <a:p>
              <a:r>
                <a:rPr lang="pt-PT" sz="1000" b="1" dirty="0">
                  <a:cs typeface="Arial" panose="020B0604020202020204" pitchFamily="34" charset="0"/>
                </a:rPr>
                <a:t>SRR1685386</a:t>
              </a:r>
              <a:r>
                <a:rPr lang="pt-PT" sz="1000" dirty="0">
                  <a:cs typeface="Arial" panose="020B0604020202020204" pitchFamily="34" charset="0"/>
                </a:rPr>
                <a:t>- University of Liverpool 2015-01-06 </a:t>
              </a:r>
              <a:r>
                <a:rPr lang="pt-PT" sz="1000" b="1" dirty="0">
                  <a:cs typeface="Arial" panose="020B0604020202020204" pitchFamily="34" charset="0"/>
                </a:rPr>
                <a:t>Sample ID: </a:t>
              </a:r>
              <a:r>
                <a:rPr lang="pt-PT" sz="1000" dirty="0">
                  <a:cs typeface="Arial" panose="020B0604020202020204" pitchFamily="34" charset="0"/>
                </a:rPr>
                <a:t>SAMN03225705 (Bowhead ID325)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50100" t="12447" r="11222" b="11918"/>
            <a:stretch/>
          </p:blipFill>
          <p:spPr>
            <a:xfrm>
              <a:off x="330792" y="1188115"/>
              <a:ext cx="6336000" cy="3490700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4" name="Rectangle 3"/>
            <p:cNvSpPr/>
            <p:nvPr/>
          </p:nvSpPr>
          <p:spPr>
            <a:xfrm>
              <a:off x="4494034" y="1148012"/>
              <a:ext cx="197922" cy="35311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3" name="Imagem 12">
            <a:extLst>
              <a:ext uri="{FF2B5EF4-FFF2-40B4-BE49-F238E27FC236}">
                <a16:creationId xmlns:a16="http://schemas.microsoft.com/office/drawing/2014/main" id="{D5A9B2DB-0FCC-4F00-A8C5-C9A491F122F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07" r="7611" b="5247"/>
          <a:stretch/>
        </p:blipFill>
        <p:spPr>
          <a:xfrm>
            <a:off x="261000" y="5451313"/>
            <a:ext cx="6336000" cy="3938882"/>
          </a:xfrm>
          <a:prstGeom prst="rect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4" name="Rectangle 3">
            <a:extLst>
              <a:ext uri="{FF2B5EF4-FFF2-40B4-BE49-F238E27FC236}">
                <a16:creationId xmlns:a16="http://schemas.microsoft.com/office/drawing/2014/main" id="{903C9AB5-49EE-402B-9E60-9FBCE8C07568}"/>
              </a:ext>
            </a:extLst>
          </p:cNvPr>
          <p:cNvSpPr/>
          <p:nvPr/>
        </p:nvSpPr>
        <p:spPr>
          <a:xfrm>
            <a:off x="4411542" y="5430163"/>
            <a:ext cx="197922" cy="39981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">
            <a:extLst>
              <a:ext uri="{FF2B5EF4-FFF2-40B4-BE49-F238E27FC236}">
                <a16:creationId xmlns:a16="http://schemas.microsoft.com/office/drawing/2014/main" id="{C9A207D7-E4BE-487E-BBAF-834E91B31094}"/>
              </a:ext>
            </a:extLst>
          </p:cNvPr>
          <p:cNvSpPr txBox="1"/>
          <p:nvPr/>
        </p:nvSpPr>
        <p:spPr>
          <a:xfrm>
            <a:off x="178836" y="4706887"/>
            <a:ext cx="6679164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00" b="1" i="1" dirty="0" err="1">
                <a:cs typeface="Arial" panose="020B0604020202020204" pitchFamily="34" charset="0"/>
              </a:rPr>
              <a:t>Lagenorhynchus</a:t>
            </a:r>
            <a:r>
              <a:rPr lang="pt-PT" sz="1100" b="1" i="1" dirty="0">
                <a:cs typeface="Arial" panose="020B0604020202020204" pitchFamily="34" charset="0"/>
              </a:rPr>
              <a:t> </a:t>
            </a:r>
            <a:r>
              <a:rPr lang="pt-PT" sz="1100" b="1" i="1" dirty="0" err="1">
                <a:cs typeface="Arial" panose="020B0604020202020204" pitchFamily="34" charset="0"/>
              </a:rPr>
              <a:t>obliquidens</a:t>
            </a:r>
            <a:r>
              <a:rPr lang="pt-PT" sz="1100" b="1" i="1" dirty="0">
                <a:cs typeface="Arial" panose="020B0604020202020204" pitchFamily="34" charset="0"/>
              </a:rPr>
              <a:t> </a:t>
            </a:r>
            <a:r>
              <a:rPr lang="pt-PT" sz="1100" b="1" dirty="0">
                <a:solidFill>
                  <a:schemeClr val="tx1"/>
                </a:solidFill>
              </a:rPr>
              <a:t>Stop codon in exon 2.</a:t>
            </a:r>
            <a:endParaRPr lang="pt-PT" sz="1100" b="1" i="1" dirty="0">
              <a:cs typeface="Arial" panose="020B0604020202020204" pitchFamily="34" charset="0"/>
            </a:endParaRPr>
          </a:p>
          <a:p>
            <a:r>
              <a:rPr lang="pt-PT" sz="1000" dirty="0">
                <a:cs typeface="Arial" panose="020B0604020202020204" pitchFamily="34" charset="0"/>
              </a:rPr>
              <a:t>SRA searched </a:t>
            </a:r>
          </a:p>
          <a:p>
            <a:r>
              <a:rPr lang="en-US" sz="1000" b="1" dirty="0">
                <a:cs typeface="Arial" panose="020B0604020202020204" pitchFamily="34" charset="0"/>
              </a:rPr>
              <a:t>SRR7349574</a:t>
            </a:r>
            <a:r>
              <a:rPr lang="en-US" sz="1000" dirty="0">
                <a:cs typeface="Arial" panose="020B0604020202020204" pitchFamily="34" charset="0"/>
              </a:rPr>
              <a:t> - BC Cancer Agency Michael Smith Genome Sciences Centre (BCCAGSC) 2018-06-21 </a:t>
            </a:r>
            <a:r>
              <a:rPr lang="pt-PT" sz="1000" b="1" dirty="0">
                <a:cs typeface="Arial" panose="020B0604020202020204" pitchFamily="34" charset="0"/>
              </a:rPr>
              <a:t>Sample ID: </a:t>
            </a:r>
            <a:r>
              <a:rPr lang="pt-PT" sz="1000" dirty="0">
                <a:cs typeface="Arial" panose="020B0604020202020204" pitchFamily="34" charset="0"/>
              </a:rPr>
              <a:t>SAMN09386610</a:t>
            </a:r>
          </a:p>
          <a:p>
            <a:r>
              <a:rPr lang="pt-PT" sz="1000" b="1" dirty="0">
                <a:cs typeface="Arial" panose="020B0604020202020204" pitchFamily="34" charset="0"/>
              </a:rPr>
              <a:t>SRR7345555</a:t>
            </a:r>
            <a:r>
              <a:rPr lang="pt-PT" sz="1000" dirty="0">
                <a:cs typeface="Arial" panose="020B0604020202020204" pitchFamily="34" charset="0"/>
              </a:rPr>
              <a:t> - </a:t>
            </a:r>
            <a:r>
              <a:rPr lang="en-US" sz="1000" dirty="0">
                <a:cs typeface="Arial" panose="020B0604020202020204" pitchFamily="34" charset="0"/>
              </a:rPr>
              <a:t>BC Cancer Agency Michael Smith Genome Sciences Centre (BCCAGSC) 2018-06-21 </a:t>
            </a:r>
            <a:r>
              <a:rPr lang="pt-PT" sz="1000" b="1" dirty="0">
                <a:cs typeface="Arial" panose="020B0604020202020204" pitchFamily="34" charset="0"/>
              </a:rPr>
              <a:t>Sample ID: </a:t>
            </a:r>
            <a:r>
              <a:rPr lang="pt-PT" sz="1000" dirty="0">
                <a:cs typeface="Arial" panose="020B0604020202020204" pitchFamily="34" charset="0"/>
              </a:rPr>
              <a:t>SAMN09386610</a:t>
            </a:r>
          </a:p>
        </p:txBody>
      </p:sp>
    </p:spTree>
    <p:extLst>
      <p:ext uri="{BB962C8B-B14F-4D97-AF65-F5344CB8AC3E}">
        <p14:creationId xmlns:p14="http://schemas.microsoft.com/office/powerpoint/2010/main" val="1787190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8</TotalTime>
  <Words>450</Words>
  <Application>Microsoft Macintosh PowerPoint</Application>
  <PresentationFormat>Papel A4 (210x297 mm)</PresentationFormat>
  <Paragraphs>44</Paragraphs>
  <Slides>6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>Universidade do Porto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ca marques</dc:creator>
  <cp:lastModifiedBy>Utilizador do Microsoft Office</cp:lastModifiedBy>
  <cp:revision>21</cp:revision>
  <dcterms:created xsi:type="dcterms:W3CDTF">2018-08-01T09:04:04Z</dcterms:created>
  <dcterms:modified xsi:type="dcterms:W3CDTF">2019-01-21T10:57:17Z</dcterms:modified>
</cp:coreProperties>
</file>